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F98463-7E8C-4E67-A030-F23B7F28627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CDBCA9-8257-485A-9015-92A3072A07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67909A-FD33-4E0C-AC7F-68A0E6F63F5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9B1D1F-EF8B-4EA9-AC0F-2ABE3B0A16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E85356-1408-49D0-8EDB-7CE7BDCB40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5F3B37-6B63-4196-B3B5-5E238B23B9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826A04-EADC-42B6-BBE1-A6C4145714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CDB2F0-B819-4035-BD20-77D9BD62EF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74B411-C7E7-4C3C-8F09-F0922CA10B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F02BDB-AA2D-403C-989F-09B228CCB9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213E5B-08EE-4831-806B-6ADD2AC382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CB212C-527C-4CC0-81C6-0A5CB0C956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103A74F-1EA9-4708-99EF-3259A096551F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533520" y="963720"/>
          <a:ext cx="7924680" cy="5240160"/>
        </p:xfrm>
        <a:graphic>
          <a:graphicData uri="http://schemas.openxmlformats.org/drawingml/2006/table">
            <a:tbl>
              <a:tblPr/>
              <a:tblGrid>
                <a:gridCol w="2517480"/>
                <a:gridCol w="5407200"/>
              </a:tblGrid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DN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audin 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ZBED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zinc finger, BED-type containing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LRP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LR family, pyrin domain containing 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DC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yndecan 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NRP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mall nuclear ribonucleoprotein polypeptides B and B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EK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IMA (never in mitosis gene a)-related kinase 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MARCD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WI/SNF related, matrix associated, actin dependent regulator of chromatin, subfamily d, member 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IK3R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hosphoinositide-3-kinase, regulatory subunit 1 (p85 alpha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SH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M and SH3 domain containing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DN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audin 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RE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piregul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5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2BP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2 (cytoplasmic tail) binding protein 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ALNT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DP-N-acetyl-alpha-D-galactosamine:polypeptide N-acetylgalactosaminyltransferase 14 (GalNAc-T14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OSTR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itric oxide synthase traffick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PN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lpain 1, (mu/I) large subuni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1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OX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RY (sex determining region Y)-box 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SBP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eat shock factor binding protein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PS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 protein pathway suppressor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PAP2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hosphatidic acid phosphatase type 2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NK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nkyrin 3, node of Ranvier (ankyrin G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L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ilamin A, alpha (actin binding protein 280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RTAP2-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eratin associated protein 2-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E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mphiregulin (schwannoma-derived growth factor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31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PPK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piplakin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KN1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yclin-dependent kinase inhibitor 1A (p21, Cip1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100A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100 calcium binding protein A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5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H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dherin 1, type 1, E-cadherin (epithelial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DC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yndecan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RT18P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eratin 18 pseudogene 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KAP8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 kinase (PRKA) anchor protein 8-lik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EGF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ultiple EGF-like-domains 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FK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hosphofructokinase, liv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CBLD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iscoidin, CUB and LCCL domain containing 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PAR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eroxisome proliferator-activated receptor gamm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BL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euroblastoma, suppression of tumorigenicity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GF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ibroblast growth factor 9 (glia-activating factor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itle 1"/>
          <p:cNvSpPr/>
          <p:nvPr/>
        </p:nvSpPr>
        <p:spPr>
          <a:xfrm>
            <a:off x="0" y="-36360"/>
            <a:ext cx="2830680" cy="68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2 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06T09:35:09Z</dcterms:created>
  <dc:creator>Admin</dc:creator>
  <dc:description/>
  <dc:language>en-US</dc:language>
  <cp:lastModifiedBy>Nome utente</cp:lastModifiedBy>
  <dcterms:modified xsi:type="dcterms:W3CDTF">2011-05-23T13:06:55Z</dcterms:modified>
  <cp:revision>256</cp:revision>
  <dc:subject/>
  <dc:title>Diapositiva 1</dc:title>
</cp:coreProperties>
</file>